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7" r:id="rId2"/>
    <p:sldId id="268" r:id="rId3"/>
    <p:sldId id="269" r:id="rId4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B296CD0-7C79-408B-A541-F2A78AA88310}" v="20" dt="2025-08-25T03:02:27.13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826" autoAdjust="0"/>
    <p:restoredTop sz="93948" autoAdjust="0"/>
  </p:normalViewPr>
  <p:slideViewPr>
    <p:cSldViewPr snapToGrid="0">
      <p:cViewPr varScale="1">
        <p:scale>
          <a:sx n="141" d="100"/>
          <a:sy n="141" d="100"/>
        </p:scale>
        <p:origin x="1692" y="33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oichiro Aoyagi" userId="66202deb61ff6c00" providerId="LiveId" clId="{1B296CD0-7C79-408B-A541-F2A78AA88310}"/>
    <pc:docChg chg="undo custSel modSld">
      <pc:chgData name="Yoichiro Aoyagi" userId="66202deb61ff6c00" providerId="LiveId" clId="{1B296CD0-7C79-408B-A541-F2A78AA88310}" dt="2025-08-25T03:04:09.202" v="899" actId="478"/>
      <pc:docMkLst>
        <pc:docMk/>
      </pc:docMkLst>
      <pc:sldChg chg="delSp modSp mod">
        <pc:chgData name="Yoichiro Aoyagi" userId="66202deb61ff6c00" providerId="LiveId" clId="{1B296CD0-7C79-408B-A541-F2A78AA88310}" dt="2025-08-25T02:50:46.527" v="64" actId="165"/>
        <pc:sldMkLst>
          <pc:docMk/>
          <pc:sldMk cId="1486306297" sldId="268"/>
        </pc:sldMkLst>
        <pc:spChg chg="mod topLvl">
          <ac:chgData name="Yoichiro Aoyagi" userId="66202deb61ff6c00" providerId="LiveId" clId="{1B296CD0-7C79-408B-A541-F2A78AA88310}" dt="2025-08-25T02:50:42.393" v="63" actId="165"/>
          <ac:spMkLst>
            <pc:docMk/>
            <pc:sldMk cId="1486306297" sldId="268"/>
            <ac:spMk id="23" creationId="{DE67C00E-3FD3-0BB6-88AB-71C116F8DBA8}"/>
          </ac:spMkLst>
        </pc:spChg>
        <pc:grpChg chg="mod">
          <ac:chgData name="Yoichiro Aoyagi" userId="66202deb61ff6c00" providerId="LiveId" clId="{1B296CD0-7C79-408B-A541-F2A78AA88310}" dt="2025-08-25T02:50:27.026" v="62" actId="1076"/>
          <ac:grpSpMkLst>
            <pc:docMk/>
            <pc:sldMk cId="1486306297" sldId="268"/>
            <ac:grpSpMk id="26" creationId="{0E95C13E-0A54-C1F9-003D-C993D0E0152A}"/>
          </ac:grpSpMkLst>
        </pc:grp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2" creationId="{8F7CA571-AA70-E8F6-EDB6-917FFC2729A1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3" creationId="{98B0CB1A-DB40-9AD0-361E-F80B690BE8F0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4" creationId="{CC84C819-E87D-35E3-17D8-36B95F1208B9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7" creationId="{44F7C941-D1FD-52EB-A248-9E6A12C177E1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9" creationId="{3528BA2C-1A89-762F-8717-8BCF66F7E296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10" creationId="{C153BAA2-A6CA-4BA2-741A-22B4F9D354ED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12" creationId="{02CE67D3-C0A2-DE7B-930F-638BF999DA6A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13" creationId="{32067AE4-64F4-05DF-C61A-69B7F19033AD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14" creationId="{6DE7A409-AAE0-6132-3696-861DAA8806A5}"/>
          </ac:picMkLst>
        </pc:picChg>
        <pc:picChg chg="mod topLvl">
          <ac:chgData name="Yoichiro Aoyagi" userId="66202deb61ff6c00" providerId="LiveId" clId="{1B296CD0-7C79-408B-A541-F2A78AA88310}" dt="2025-08-25T02:50:46.527" v="64" actId="165"/>
          <ac:picMkLst>
            <pc:docMk/>
            <pc:sldMk cId="1486306297" sldId="268"/>
            <ac:picMk id="16" creationId="{443C4687-52D8-836E-36EA-FF048B60E2E2}"/>
          </ac:picMkLst>
        </pc:picChg>
      </pc:sldChg>
      <pc:sldChg chg="addSp delSp modSp mod">
        <pc:chgData name="Yoichiro Aoyagi" userId="66202deb61ff6c00" providerId="LiveId" clId="{1B296CD0-7C79-408B-A541-F2A78AA88310}" dt="2025-08-25T03:04:09.202" v="899" actId="478"/>
        <pc:sldMkLst>
          <pc:docMk/>
          <pc:sldMk cId="3323815572" sldId="269"/>
        </pc:sldMkLst>
        <pc:picChg chg="mod">
          <ac:chgData name="Yoichiro Aoyagi" userId="66202deb61ff6c00" providerId="LiveId" clId="{1B296CD0-7C79-408B-A541-F2A78AA88310}" dt="2025-08-25T02:59:10.716" v="587" actId="1035"/>
          <ac:picMkLst>
            <pc:docMk/>
            <pc:sldMk cId="3323815572" sldId="269"/>
            <ac:picMk id="4" creationId="{A8142712-0AD4-0FC6-85A1-C3EEFAB40756}"/>
          </ac:picMkLst>
        </pc:picChg>
        <pc:picChg chg="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6" creationId="{F037D9B2-E980-A8D3-7A90-E41A49BCB8B4}"/>
          </ac:picMkLst>
        </pc:picChg>
        <pc:picChg chg="add mod">
          <ac:chgData name="Yoichiro Aoyagi" userId="66202deb61ff6c00" providerId="LiveId" clId="{1B296CD0-7C79-408B-A541-F2A78AA88310}" dt="2025-08-25T02:50:25.308" v="61" actId="1037"/>
          <ac:picMkLst>
            <pc:docMk/>
            <pc:sldMk cId="3323815572" sldId="269"/>
            <ac:picMk id="7" creationId="{C4669BA6-9305-20F6-2CFE-6288F15580C6}"/>
          </ac:picMkLst>
        </pc:picChg>
        <pc:picChg chg="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8" creationId="{1BB3ACFF-3BA2-BC5B-1D26-939C213CC8E4}"/>
          </ac:picMkLst>
        </pc:picChg>
        <pc:picChg chg="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9" creationId="{EB570C96-85E8-4585-E587-EC18AD9AE7CB}"/>
          </ac:picMkLst>
        </pc:picChg>
        <pc:picChg chg="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10" creationId="{23622BA4-2D4B-A30F-7DF0-FFE4E7A3DB37}"/>
          </ac:picMkLst>
        </pc:picChg>
        <pc:picChg chg="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11" creationId="{0809B846-FF37-7923-021D-80FE44423076}"/>
          </ac:picMkLst>
        </pc:picChg>
        <pc:picChg chg="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13" creationId="{351F4DE2-1810-6423-C8E0-36AF6F4C4C5C}"/>
          </ac:picMkLst>
        </pc:picChg>
        <pc:picChg chg="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14" creationId="{6ED9B817-084F-47D3-1A32-A65E0F5AD14C}"/>
          </ac:picMkLst>
        </pc:picChg>
        <pc:picChg chg="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15" creationId="{C1F6861E-FC5C-1D5B-9BC3-0296A6961DB7}"/>
          </ac:picMkLst>
        </pc:picChg>
        <pc:picChg chg="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16" creationId="{49D8B962-DD5C-C446-0662-3B85FA637B0D}"/>
          </ac:picMkLst>
        </pc:picChg>
        <pc:picChg chg="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17" creationId="{048828DD-1AF9-0E15-33D4-1FC3DA74026E}"/>
          </ac:picMkLst>
        </pc:picChg>
        <pc:picChg chg="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18" creationId="{34490A04-3A92-6E88-89DF-A9D45D2CCF9C}"/>
          </ac:picMkLst>
        </pc:picChg>
        <pc:picChg chg="add del mod">
          <ac:chgData name="Yoichiro Aoyagi" userId="66202deb61ff6c00" providerId="LiveId" clId="{1B296CD0-7C79-408B-A541-F2A78AA88310}" dt="2025-08-25T02:53:57.781" v="192" actId="478"/>
          <ac:picMkLst>
            <pc:docMk/>
            <pc:sldMk cId="3323815572" sldId="269"/>
            <ac:picMk id="20" creationId="{BBE9BB6F-B24C-C0F4-215F-41BAD4D1A455}"/>
          </ac:picMkLst>
        </pc:picChg>
        <pc:picChg chg="add del mod">
          <ac:chgData name="Yoichiro Aoyagi" userId="66202deb61ff6c00" providerId="LiveId" clId="{1B296CD0-7C79-408B-A541-F2A78AA88310}" dt="2025-08-25T02:53:57.781" v="192" actId="478"/>
          <ac:picMkLst>
            <pc:docMk/>
            <pc:sldMk cId="3323815572" sldId="269"/>
            <ac:picMk id="22" creationId="{D7FF8DB7-D48C-FF04-2271-E06224E1D368}"/>
          </ac:picMkLst>
        </pc:picChg>
        <pc:picChg chg="add del mod">
          <ac:chgData name="Yoichiro Aoyagi" userId="66202deb61ff6c00" providerId="LiveId" clId="{1B296CD0-7C79-408B-A541-F2A78AA88310}" dt="2025-08-25T02:53:57.781" v="192" actId="478"/>
          <ac:picMkLst>
            <pc:docMk/>
            <pc:sldMk cId="3323815572" sldId="269"/>
            <ac:picMk id="24" creationId="{A4122896-EE0E-58B2-C2CF-BF0D0ADB819D}"/>
          </ac:picMkLst>
        </pc:picChg>
        <pc:picChg chg="mod">
          <ac:chgData name="Yoichiro Aoyagi" userId="66202deb61ff6c00" providerId="LiveId" clId="{1B296CD0-7C79-408B-A541-F2A78AA88310}" dt="2025-08-25T03:03:26.348" v="898" actId="1036"/>
          <ac:picMkLst>
            <pc:docMk/>
            <pc:sldMk cId="3323815572" sldId="269"/>
            <ac:picMk id="25" creationId="{5F83D43B-710F-A1DF-1E60-C5F9FB63855A}"/>
          </ac:picMkLst>
        </pc:picChg>
        <pc:picChg chg="mod">
          <ac:chgData name="Yoichiro Aoyagi" userId="66202deb61ff6c00" providerId="LiveId" clId="{1B296CD0-7C79-408B-A541-F2A78AA88310}" dt="2025-08-25T03:03:26.348" v="898" actId="1036"/>
          <ac:picMkLst>
            <pc:docMk/>
            <pc:sldMk cId="3323815572" sldId="269"/>
            <ac:picMk id="26" creationId="{FA4B7743-357A-AE6D-01EB-93038BFA95B7}"/>
          </ac:picMkLst>
        </pc:picChg>
        <pc:picChg chg="add del mod">
          <ac:chgData name="Yoichiro Aoyagi" userId="66202deb61ff6c00" providerId="LiveId" clId="{1B296CD0-7C79-408B-A541-F2A78AA88310}" dt="2025-08-25T02:53:57.781" v="192" actId="478"/>
          <ac:picMkLst>
            <pc:docMk/>
            <pc:sldMk cId="3323815572" sldId="269"/>
            <ac:picMk id="27" creationId="{7288F72A-ACFB-ACCB-1C8F-693E4DFB6852}"/>
          </ac:picMkLst>
        </pc:picChg>
        <pc:picChg chg="add del mod">
          <ac:chgData name="Yoichiro Aoyagi" userId="66202deb61ff6c00" providerId="LiveId" clId="{1B296CD0-7C79-408B-A541-F2A78AA88310}" dt="2025-08-25T02:53:57.781" v="192" actId="478"/>
          <ac:picMkLst>
            <pc:docMk/>
            <pc:sldMk cId="3323815572" sldId="269"/>
            <ac:picMk id="28" creationId="{C7FAB7ED-E3D1-C55C-D823-6C32B9A9AA6D}"/>
          </ac:picMkLst>
        </pc:picChg>
        <pc:picChg chg="add del mod">
          <ac:chgData name="Yoichiro Aoyagi" userId="66202deb61ff6c00" providerId="LiveId" clId="{1B296CD0-7C79-408B-A541-F2A78AA88310}" dt="2025-08-25T02:53:57.781" v="192" actId="478"/>
          <ac:picMkLst>
            <pc:docMk/>
            <pc:sldMk cId="3323815572" sldId="269"/>
            <ac:picMk id="29" creationId="{D792D696-1EAA-319D-C773-6B25AA6537B5}"/>
          </ac:picMkLst>
        </pc:picChg>
        <pc:picChg chg="add 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30" creationId="{C2281E68-9509-E8CC-3A98-2C41A16971E6}"/>
          </ac:picMkLst>
        </pc:picChg>
        <pc:picChg chg="add 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31" creationId="{9E1CDB13-E694-7E1B-F112-911E3DB3504D}"/>
          </ac:picMkLst>
        </pc:picChg>
        <pc:picChg chg="add 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32" creationId="{80F207E3-E728-8A7F-F659-C081C7DDD2B9}"/>
          </ac:picMkLst>
        </pc:picChg>
        <pc:picChg chg="add 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33" creationId="{2A5D196A-7D88-8937-7D67-60E44ECFFA23}"/>
          </ac:picMkLst>
        </pc:picChg>
        <pc:picChg chg="add mod">
          <ac:chgData name="Yoichiro Aoyagi" userId="66202deb61ff6c00" providerId="LiveId" clId="{1B296CD0-7C79-408B-A541-F2A78AA88310}" dt="2025-08-25T02:54:13.923" v="287" actId="1037"/>
          <ac:picMkLst>
            <pc:docMk/>
            <pc:sldMk cId="3323815572" sldId="269"/>
            <ac:picMk id="34" creationId="{338664DD-7508-2703-9B13-A3416333D0A5}"/>
          </ac:picMkLst>
        </pc:picChg>
        <pc:picChg chg="add mod">
          <ac:chgData name="Yoichiro Aoyagi" userId="66202deb61ff6c00" providerId="LiveId" clId="{1B296CD0-7C79-408B-A541-F2A78AA88310}" dt="2025-08-25T02:54:26.169" v="288" actId="1037"/>
          <ac:picMkLst>
            <pc:docMk/>
            <pc:sldMk cId="3323815572" sldId="269"/>
            <ac:picMk id="35" creationId="{66210069-F589-9CAF-C90D-E05DEEE51711}"/>
          </ac:picMkLst>
        </pc:picChg>
        <pc:picChg chg="add mod">
          <ac:chgData name="Yoichiro Aoyagi" userId="66202deb61ff6c00" providerId="LiveId" clId="{1B296CD0-7C79-408B-A541-F2A78AA88310}" dt="2025-08-25T02:55:50.862" v="304" actId="1037"/>
          <ac:picMkLst>
            <pc:docMk/>
            <pc:sldMk cId="3323815572" sldId="269"/>
            <ac:picMk id="36" creationId="{DEED5947-8D8B-4B7A-8033-A863C878D8CD}"/>
          </ac:picMkLst>
        </pc:picChg>
        <pc:picChg chg="add mod">
          <ac:chgData name="Yoichiro Aoyagi" userId="66202deb61ff6c00" providerId="LiveId" clId="{1B296CD0-7C79-408B-A541-F2A78AA88310}" dt="2025-08-25T02:55:50.862" v="304" actId="1037"/>
          <ac:picMkLst>
            <pc:docMk/>
            <pc:sldMk cId="3323815572" sldId="269"/>
            <ac:picMk id="37" creationId="{F41BBD45-826C-3BA9-259F-75543F19E58C}"/>
          </ac:picMkLst>
        </pc:picChg>
        <pc:picChg chg="add mod">
          <ac:chgData name="Yoichiro Aoyagi" userId="66202deb61ff6c00" providerId="LiveId" clId="{1B296CD0-7C79-408B-A541-F2A78AA88310}" dt="2025-08-25T02:55:50.862" v="304" actId="1037"/>
          <ac:picMkLst>
            <pc:docMk/>
            <pc:sldMk cId="3323815572" sldId="269"/>
            <ac:picMk id="38" creationId="{ACCFE940-EA85-D318-4F1A-493098DE5E6B}"/>
          </ac:picMkLst>
        </pc:picChg>
        <pc:picChg chg="add mod">
          <ac:chgData name="Yoichiro Aoyagi" userId="66202deb61ff6c00" providerId="LiveId" clId="{1B296CD0-7C79-408B-A541-F2A78AA88310}" dt="2025-08-25T02:56:50.727" v="308" actId="1035"/>
          <ac:picMkLst>
            <pc:docMk/>
            <pc:sldMk cId="3323815572" sldId="269"/>
            <ac:picMk id="39" creationId="{D35A924C-0CDF-0561-19F1-CF68B1AB13EC}"/>
          </ac:picMkLst>
        </pc:picChg>
        <pc:picChg chg="add mod">
          <ac:chgData name="Yoichiro Aoyagi" userId="66202deb61ff6c00" providerId="LiveId" clId="{1B296CD0-7C79-408B-A541-F2A78AA88310}" dt="2025-08-25T02:56:50.727" v="308" actId="1035"/>
          <ac:picMkLst>
            <pc:docMk/>
            <pc:sldMk cId="3323815572" sldId="269"/>
            <ac:picMk id="40" creationId="{79CB7443-368F-BB7F-A71F-9A4AE5727518}"/>
          </ac:picMkLst>
        </pc:picChg>
        <pc:picChg chg="add mod">
          <ac:chgData name="Yoichiro Aoyagi" userId="66202deb61ff6c00" providerId="LiveId" clId="{1B296CD0-7C79-408B-A541-F2A78AA88310}" dt="2025-08-25T02:56:50.727" v="308" actId="1035"/>
          <ac:picMkLst>
            <pc:docMk/>
            <pc:sldMk cId="3323815572" sldId="269"/>
            <ac:picMk id="41" creationId="{8D30712D-864A-B2C4-12F3-C6C72213A661}"/>
          </ac:picMkLst>
        </pc:picChg>
        <pc:picChg chg="add mod">
          <ac:chgData name="Yoichiro Aoyagi" userId="66202deb61ff6c00" providerId="LiveId" clId="{1B296CD0-7C79-408B-A541-F2A78AA88310}" dt="2025-08-25T03:03:26.348" v="898" actId="1036"/>
          <ac:picMkLst>
            <pc:docMk/>
            <pc:sldMk cId="3323815572" sldId="269"/>
            <ac:picMk id="42" creationId="{88E82081-2D99-E64A-8AB1-3BB15991BBB2}"/>
          </ac:picMkLst>
        </pc:picChg>
        <pc:picChg chg="add mod">
          <ac:chgData name="Yoichiro Aoyagi" userId="66202deb61ff6c00" providerId="LiveId" clId="{1B296CD0-7C79-408B-A541-F2A78AA88310}" dt="2025-08-25T02:59:10.716" v="587" actId="1035"/>
          <ac:picMkLst>
            <pc:docMk/>
            <pc:sldMk cId="3323815572" sldId="269"/>
            <ac:picMk id="43" creationId="{E337B6E9-DE5C-D496-FA38-28B257BC7E84}"/>
          </ac:picMkLst>
        </pc:picChg>
        <pc:picChg chg="add mod">
          <ac:chgData name="Yoichiro Aoyagi" userId="66202deb61ff6c00" providerId="LiveId" clId="{1B296CD0-7C79-408B-A541-F2A78AA88310}" dt="2025-08-25T02:58:07.692" v="462" actId="1035"/>
          <ac:picMkLst>
            <pc:docMk/>
            <pc:sldMk cId="3323815572" sldId="269"/>
            <ac:picMk id="44" creationId="{93A0BB1E-D71B-ACC3-AACD-5FA4376551A2}"/>
          </ac:picMkLst>
        </pc:picChg>
        <pc:picChg chg="add mod">
          <ac:chgData name="Yoichiro Aoyagi" userId="66202deb61ff6c00" providerId="LiveId" clId="{1B296CD0-7C79-408B-A541-F2A78AA88310}" dt="2025-08-25T03:01:25.896" v="704" actId="1037"/>
          <ac:picMkLst>
            <pc:docMk/>
            <pc:sldMk cId="3323815572" sldId="269"/>
            <ac:picMk id="45" creationId="{E4492833-62AB-79A0-D086-EF1A3DE50047}"/>
          </ac:picMkLst>
        </pc:picChg>
        <pc:picChg chg="add del mod">
          <ac:chgData name="Yoichiro Aoyagi" userId="66202deb61ff6c00" providerId="LiveId" clId="{1B296CD0-7C79-408B-A541-F2A78AA88310}" dt="2025-08-25T03:04:09.202" v="899" actId="478"/>
          <ac:picMkLst>
            <pc:docMk/>
            <pc:sldMk cId="3323815572" sldId="269"/>
            <ac:picMk id="46" creationId="{98F033F7-B2FA-CD7A-7779-4C4DF498C538}"/>
          </ac:picMkLst>
        </pc:picChg>
        <pc:picChg chg="add del mod">
          <ac:chgData name="Yoichiro Aoyagi" userId="66202deb61ff6c00" providerId="LiveId" clId="{1B296CD0-7C79-408B-A541-F2A78AA88310}" dt="2025-08-25T03:04:09.202" v="899" actId="478"/>
          <ac:picMkLst>
            <pc:docMk/>
            <pc:sldMk cId="3323815572" sldId="269"/>
            <ac:picMk id="47" creationId="{AD4369F4-E8F0-0FD3-61BA-A334DBD3DE42}"/>
          </ac:picMkLst>
        </pc:picChg>
        <pc:picChg chg="add del mod">
          <ac:chgData name="Yoichiro Aoyagi" userId="66202deb61ff6c00" providerId="LiveId" clId="{1B296CD0-7C79-408B-A541-F2A78AA88310}" dt="2025-08-25T03:04:09.202" v="899" actId="478"/>
          <ac:picMkLst>
            <pc:docMk/>
            <pc:sldMk cId="3323815572" sldId="269"/>
            <ac:picMk id="48" creationId="{201853F7-B105-AB65-7CBC-704E801E04A9}"/>
          </ac:picMkLst>
        </pc:picChg>
        <pc:picChg chg="add del mod">
          <ac:chgData name="Yoichiro Aoyagi" userId="66202deb61ff6c00" providerId="LiveId" clId="{1B296CD0-7C79-408B-A541-F2A78AA88310}" dt="2025-08-25T03:04:09.202" v="899" actId="478"/>
          <ac:picMkLst>
            <pc:docMk/>
            <pc:sldMk cId="3323815572" sldId="269"/>
            <ac:picMk id="49" creationId="{8281FC59-F71C-41D2-B613-4DC725CCB58E}"/>
          </ac:picMkLst>
        </pc:picChg>
        <pc:picChg chg="add del mod">
          <ac:chgData name="Yoichiro Aoyagi" userId="66202deb61ff6c00" providerId="LiveId" clId="{1B296CD0-7C79-408B-A541-F2A78AA88310}" dt="2025-08-25T03:04:09.202" v="899" actId="478"/>
          <ac:picMkLst>
            <pc:docMk/>
            <pc:sldMk cId="3323815572" sldId="269"/>
            <ac:picMk id="50" creationId="{FD5CA077-1C1F-1D8E-3B13-DAB6F4B761E1}"/>
          </ac:picMkLst>
        </pc:picChg>
        <pc:picChg chg="add del mod">
          <ac:chgData name="Yoichiro Aoyagi" userId="66202deb61ff6c00" providerId="LiveId" clId="{1B296CD0-7C79-408B-A541-F2A78AA88310}" dt="2025-08-25T03:04:09.202" v="899" actId="478"/>
          <ac:picMkLst>
            <pc:docMk/>
            <pc:sldMk cId="3323815572" sldId="269"/>
            <ac:picMk id="51" creationId="{23A0EB9D-FA8D-AB44-54A6-74CAB305E52C}"/>
          </ac:picMkLst>
        </pc:picChg>
        <pc:picChg chg="add del mod">
          <ac:chgData name="Yoichiro Aoyagi" userId="66202deb61ff6c00" providerId="LiveId" clId="{1B296CD0-7C79-408B-A541-F2A78AA88310}" dt="2025-08-25T03:04:09.202" v="899" actId="478"/>
          <ac:picMkLst>
            <pc:docMk/>
            <pc:sldMk cId="3323815572" sldId="269"/>
            <ac:picMk id="52" creationId="{63CAA23D-D853-9C21-8BC4-0DD30EB91781}"/>
          </ac:picMkLst>
        </pc:picChg>
        <pc:picChg chg="add mod">
          <ac:chgData name="Yoichiro Aoyagi" userId="66202deb61ff6c00" providerId="LiveId" clId="{1B296CD0-7C79-408B-A541-F2A78AA88310}" dt="2025-08-25T03:03:26.348" v="898" actId="1036"/>
          <ac:picMkLst>
            <pc:docMk/>
            <pc:sldMk cId="3323815572" sldId="269"/>
            <ac:picMk id="53" creationId="{C5E95AB8-546D-366B-51C2-DEFAE17CF641}"/>
          </ac:picMkLst>
        </pc:picChg>
      </pc:sldChg>
    </pc:docChg>
  </pc:docChgLst>
  <pc:docChgLst>
    <pc:chgData name="Yoichiro Aoyagi" userId="66202deb61ff6c00" providerId="LiveId" clId="{A9722E2D-25A0-4A28-877E-3349E16600E6}"/>
    <pc:docChg chg="delSld modSld">
      <pc:chgData name="Yoichiro Aoyagi" userId="66202deb61ff6c00" providerId="LiveId" clId="{A9722E2D-25A0-4A28-877E-3349E16600E6}" dt="2025-05-01T05:28:14.838" v="3" actId="14100"/>
      <pc:docMkLst>
        <pc:docMk/>
      </pc:docMkLst>
      <pc:sldChg chg="del">
        <pc:chgData name="Yoichiro Aoyagi" userId="66202deb61ff6c00" providerId="LiveId" clId="{A9722E2D-25A0-4A28-877E-3349E16600E6}" dt="2025-05-01T01:05:50.705" v="0" actId="2696"/>
        <pc:sldMkLst>
          <pc:docMk/>
          <pc:sldMk cId="2784793677" sldId="256"/>
        </pc:sldMkLst>
      </pc:sldChg>
      <pc:sldChg chg="del">
        <pc:chgData name="Yoichiro Aoyagi" userId="66202deb61ff6c00" providerId="LiveId" clId="{A9722E2D-25A0-4A28-877E-3349E16600E6}" dt="2025-05-01T01:05:50.705" v="0" actId="2696"/>
        <pc:sldMkLst>
          <pc:docMk/>
          <pc:sldMk cId="867661940" sldId="262"/>
        </pc:sldMkLst>
      </pc:sldChg>
      <pc:sldChg chg="del">
        <pc:chgData name="Yoichiro Aoyagi" userId="66202deb61ff6c00" providerId="LiveId" clId="{A9722E2D-25A0-4A28-877E-3349E16600E6}" dt="2025-05-01T01:05:50.705" v="0" actId="2696"/>
        <pc:sldMkLst>
          <pc:docMk/>
          <pc:sldMk cId="4258331019" sldId="264"/>
        </pc:sldMkLst>
      </pc:sldChg>
      <pc:sldChg chg="del">
        <pc:chgData name="Yoichiro Aoyagi" userId="66202deb61ff6c00" providerId="LiveId" clId="{A9722E2D-25A0-4A28-877E-3349E16600E6}" dt="2025-05-01T01:05:50.705" v="0" actId="2696"/>
        <pc:sldMkLst>
          <pc:docMk/>
          <pc:sldMk cId="580213562" sldId="266"/>
        </pc:sldMkLst>
      </pc:sldChg>
      <pc:sldChg chg="modSp mod">
        <pc:chgData name="Yoichiro Aoyagi" userId="66202deb61ff6c00" providerId="LiveId" clId="{A9722E2D-25A0-4A28-877E-3349E16600E6}" dt="2025-05-01T01:59:26.546" v="2" actId="1076"/>
        <pc:sldMkLst>
          <pc:docMk/>
          <pc:sldMk cId="785367565" sldId="267"/>
        </pc:sldMkLst>
      </pc:sldChg>
      <pc:sldChg chg="modSp mod">
        <pc:chgData name="Yoichiro Aoyagi" userId="66202deb61ff6c00" providerId="LiveId" clId="{A9722E2D-25A0-4A28-877E-3349E16600E6}" dt="2025-05-01T05:28:14.838" v="3" actId="14100"/>
        <pc:sldMkLst>
          <pc:docMk/>
          <pc:sldMk cId="1486306297" sldId="26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097427-1F92-5048-803E-5F2D9FBFD50B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455894-7EFE-8C49-A0F7-47063133B0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9584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455894-7EFE-8C49-A0F7-47063133B05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5166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455894-7EFE-8C49-A0F7-47063133B05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415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EF7221-B164-95D8-8139-533FD34472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BC48B8C-A968-335A-2315-77183AE976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007D30-1B87-4047-CA68-486CB3034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968C9A-5C57-AD15-FECF-D0BAED783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3A90D8-AD23-9122-F80C-9F0BE7F77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73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B1A046-B8DA-6C45-A67C-5FA6AD4F93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D556825-8382-3A84-1480-876067723C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3F65E9-8800-B621-E03D-B5152913B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F00436-2548-ECFC-E493-3DEE717E2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7F9A6F-058E-33B1-6BF7-417660915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5791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1EE5FAC-24CA-D73D-FE6C-AB4F52CB3C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553A09C-30C1-F27F-D445-E3493ABFAB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CC1D56-3570-CBDF-4EDD-9394E53BA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3B14B2-3DEA-1816-308B-3FE77EBCE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DB0670-1110-4536-CD19-872E7ACAB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5867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7B3EC9-48D0-F536-788E-2AD880A3FE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70F2A0-C19F-068E-389C-0865002E5E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10E7FC-4B95-A473-9A76-EF1A6D826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B41DDA-B666-6A11-7F52-E3D0C5AE6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191483-E2A3-783E-6DB3-14AD5F524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0348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485493-6CE6-DCED-EB7B-EA4878F45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BAF9BA-A024-E117-3FD1-5571E8742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75EF87-29DF-E0E6-DE68-E1EFD7DF7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6433C5-CFA6-2EBE-F6DC-DDE9241D3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CA2DDA-95E4-F73C-3ECD-B5F6E43FA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220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577D1D-C6C3-4EC4-F113-86F81CCBAD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8985998-AFF1-BA9E-CD6F-B4E9DF29F8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9A4CDFC-C3C8-14DA-6493-C27774E5D6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3CA43F-2C27-2BEA-01B9-BC1EDADDE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2C581C9-7F6F-EBED-2141-A4235B55D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B55E09A-3425-6F96-4F4C-B91319EB6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545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A6B20B-9613-5EF0-760C-59D4702A0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97B56F-A2CA-C29C-6B4E-BF25496E32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A6E66EF-5D51-28A4-E5C1-B4537350CD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7CC8C5B-42BD-0F34-E282-872A12011F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79DDBE0-335D-963F-978A-9DDDA448BC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3BACC61-4713-7784-689E-B038B15B9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3359C67-150C-E074-88C5-A4C9A4A95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B9192AD-998C-5B5D-7122-683CBE559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352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5834C9-A6B2-9336-C47C-F5D79289D6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D18CA30-CD1C-F3F7-0C4B-7439D656F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729A2F9-ED5E-7F0A-57E6-107ACC0C3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4AD6022-5B6C-4C2D-62CF-640A89263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982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87669ED-45A4-5D78-9177-62A3DE61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B17A7F4-9C14-EF10-2CD7-62478E4FE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783603F-4C92-0E17-A4CC-0E30D9486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567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116210-7BCD-205F-A7C1-2989E1C69E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6D990C-ED86-79D7-03DA-07797D7878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7D59FCD-030E-1819-0F35-D336CEE7F4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59B823-7E07-77C0-56DA-3A350556BC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EFA17B5-575A-0E36-41EE-CF370971C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0364D2E-96EA-C721-40EC-F07C2ECFE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8124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81B9FF-D19E-170A-DE03-A53D1D7FD0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1D6153C-4900-5057-B9C2-2BE5BAD878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70AB0BF-BA57-7119-3417-57DDC5B382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8D3E71-80E5-3280-E41B-AE3C296E9A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87D7DD6-3CC7-9266-98F0-09825BD38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B4F979-4CAF-ED37-809F-425518B0F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4521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9F63285-EFA7-1316-4FE8-98E8825AAE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2A8281-5014-ABE3-3070-909A7D8F75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2EB9D4-9FE8-C318-314F-D9ED1761D1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881086-CA3F-4D15-9B2A-4C77E4167FF7}" type="datetimeFigureOut">
              <a:rPr kumimoji="1" lang="ja-JP" altLang="en-US" smtClean="0"/>
              <a:t>2025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961B57-EF72-6B5A-FD7D-AF8E59208D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F826F3-F52F-30A7-78B2-03336FB108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B0793C-8FE0-4B4B-B912-FDB0348A6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883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f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横たわっている男&#10;&#10;低い精度で自動的に生成された説明">
            <a:extLst>
              <a:ext uri="{FF2B5EF4-FFF2-40B4-BE49-F238E27FC236}">
                <a16:creationId xmlns:a16="http://schemas.microsoft.com/office/drawing/2014/main" id="{AB7ED6D9-3300-C0F0-796B-59E2C7084B8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461" t="23493" r="1" b="-1"/>
          <a:stretch/>
        </p:blipFill>
        <p:spPr>
          <a:xfrm rot="5400000">
            <a:off x="4576374" y="1757572"/>
            <a:ext cx="3039252" cy="258211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533F304-3B02-EFF7-C327-7EED90E06888}"/>
              </a:ext>
            </a:extLst>
          </p:cNvPr>
          <p:cNvSpPr txBox="1"/>
          <p:nvPr/>
        </p:nvSpPr>
        <p:spPr>
          <a:xfrm>
            <a:off x="479131" y="338683"/>
            <a:ext cx="6794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5367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5B4D5EC-D76D-B9A4-491F-7106C1C25DBB}"/>
              </a:ext>
            </a:extLst>
          </p:cNvPr>
          <p:cNvSpPr txBox="1"/>
          <p:nvPr/>
        </p:nvSpPr>
        <p:spPr>
          <a:xfrm>
            <a:off x="304856" y="235817"/>
            <a:ext cx="917307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8F7CA571-AA70-E8F6-EDB6-917FFC2729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7057" y="1139244"/>
            <a:ext cx="7772400" cy="457951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98B0CB1A-DB40-9AD0-361E-F80B690BE8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4894180" y="3744545"/>
            <a:ext cx="90872" cy="9087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CC84C819-E87D-35E3-17D8-36B95F1208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0800000">
            <a:off x="3322049" y="4300116"/>
            <a:ext cx="107311" cy="10254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A6DDC1D-7B13-9475-6073-5D76F7B40B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4572" y="4283841"/>
            <a:ext cx="107311" cy="102541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265D170D-7A39-6DA7-22EC-A8EE682244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0800000">
            <a:off x="4891392" y="4300116"/>
            <a:ext cx="107311" cy="10254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44F7C941-D1FD-52EB-A248-9E6A12C177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64757" y="4283841"/>
            <a:ext cx="107311" cy="102541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9A54551A-F50D-6467-5CB0-DC17E85398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0800000">
            <a:off x="5076593" y="4300115"/>
            <a:ext cx="107311" cy="10254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528BA2C-1A89-762F-8717-8BCF66F7E2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84069" y="4283841"/>
            <a:ext cx="107311" cy="10254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153BAA2-A6CA-4BA2-741A-22B4F9D354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0800000">
            <a:off x="6453177" y="4300115"/>
            <a:ext cx="107311" cy="102541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B3D2260-3B81-995D-9A1E-63482703F3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47072" y="4283840"/>
            <a:ext cx="107311" cy="102541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2CE67D3-C0A2-DE7B-930F-638BF999DA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6461396" y="4163225"/>
            <a:ext cx="90872" cy="9087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32067AE4-64F4-05DF-C61A-69B7F19033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6546772" y="4157686"/>
            <a:ext cx="90872" cy="9087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6DE7A409-AAE0-6132-3696-861DAA8806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6465976" y="4026336"/>
            <a:ext cx="90872" cy="90872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7C18AA05-3136-A78F-55DC-9A86B09039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6637645" y="4026336"/>
            <a:ext cx="90872" cy="90872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443C4687-52D8-836E-36EA-FF048B60E2E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6551441" y="4026336"/>
            <a:ext cx="90872" cy="90872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E67C00E-3FD3-0BB6-88AB-71C116F8DBA8}"/>
              </a:ext>
            </a:extLst>
          </p:cNvPr>
          <p:cNvSpPr txBox="1"/>
          <p:nvPr/>
        </p:nvSpPr>
        <p:spPr>
          <a:xfrm>
            <a:off x="4701209" y="5303719"/>
            <a:ext cx="3467879" cy="2785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10" b="1" dirty="0">
                <a:latin typeface="Arial" panose="020B0604020202020204" pitchFamily="34" charset="0"/>
                <a:cs typeface="Arial" panose="020B0604020202020204" pitchFamily="34" charset="0"/>
              </a:rPr>
              <a:t>Change in RSST (number of times)</a:t>
            </a:r>
            <a:endParaRPr kumimoji="1" lang="ja-JP" altLang="en-US" sz="12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63062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22CC636-F032-A6FA-BF0E-A276C1E6F6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6798" y="3730429"/>
            <a:ext cx="90872" cy="9087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D8DAD17-B28D-0494-5DCF-38A2FDACD1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64712" y="4286566"/>
            <a:ext cx="107311" cy="10254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A8142712-0AD4-0FC6-85A1-C3EEFAB407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7837" y="4426952"/>
            <a:ext cx="90872" cy="9087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F037D9B2-E980-A8D3-7A90-E41A49BCB8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7644" y="4153809"/>
            <a:ext cx="90872" cy="9087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BB3ACFF-3BA2-BC5B-1D26-939C213CC8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64334" y="4286565"/>
            <a:ext cx="107311" cy="10254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EB570C96-85E8-4585-E587-EC18AD9AE7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55206" y="4286564"/>
            <a:ext cx="107311" cy="10254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23622BA4-2D4B-A30F-7DF0-FFE4E7A3DB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8516" y="4153809"/>
            <a:ext cx="90872" cy="90872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809B846-FF37-7923-021D-80FE444230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49388" y="4153809"/>
            <a:ext cx="90872" cy="90872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C4C04423-6663-460F-5796-2B848BCAE8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7644" y="4013342"/>
            <a:ext cx="90872" cy="9087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351F4DE2-1810-6423-C8E0-36AF6F4C4C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8516" y="4013342"/>
            <a:ext cx="90872" cy="9087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6ED9B817-084F-47D3-1A32-A65E0F5AD1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49388" y="4013342"/>
            <a:ext cx="90872" cy="90872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C1F6861E-FC5C-1D5B-9BC3-0296A6961D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39026" y="4286565"/>
            <a:ext cx="107311" cy="102541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49D8B962-DD5C-C446-0662-3B85FA637B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38648" y="4286564"/>
            <a:ext cx="107311" cy="102541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48828DD-1AF9-0E15-33D4-1FC3DA7402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9520" y="4286563"/>
            <a:ext cx="107311" cy="10254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34490A04-3A92-6E88-89DF-A9D45D2CCF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20392" y="4286562"/>
            <a:ext cx="107311" cy="102541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5F83D43B-710F-A1DF-1E60-C5F9FB6385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10910" y="4292866"/>
            <a:ext cx="107311" cy="102541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FA4B7743-357A-AE6D-01EB-93038BFA95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10532" y="4292865"/>
            <a:ext cx="107311" cy="102541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1717742-84B8-71CC-C14D-D7EAD33A6ECA}"/>
              </a:ext>
            </a:extLst>
          </p:cNvPr>
          <p:cNvSpPr txBox="1"/>
          <p:nvPr/>
        </p:nvSpPr>
        <p:spPr>
          <a:xfrm>
            <a:off x="307192" y="198542"/>
            <a:ext cx="93161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96BB4BA-0123-584C-E18B-38E26F315D4A}"/>
              </a:ext>
            </a:extLst>
          </p:cNvPr>
          <p:cNvGrpSpPr/>
          <p:nvPr/>
        </p:nvGrpSpPr>
        <p:grpSpPr>
          <a:xfrm>
            <a:off x="2209800" y="1137372"/>
            <a:ext cx="7772400" cy="4583255"/>
            <a:chOff x="2209800" y="1137372"/>
            <a:chExt cx="7772400" cy="4583255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1E412B52-A66E-76BF-D686-5FE32670EE1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09800" y="1137372"/>
              <a:ext cx="7772400" cy="4583255"/>
            </a:xfrm>
            <a:prstGeom prst="rect">
              <a:avLst/>
            </a:prstGeom>
          </p:spPr>
        </p:pic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B5C92F44-6BD1-0DF2-2931-AB52053F98DD}"/>
                </a:ext>
              </a:extLst>
            </p:cNvPr>
            <p:cNvSpPr txBox="1"/>
            <p:nvPr/>
          </p:nvSpPr>
          <p:spPr>
            <a:xfrm>
              <a:off x="5484638" y="5327933"/>
              <a:ext cx="1922321" cy="280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210" b="1" dirty="0">
                  <a:latin typeface="Arial" panose="020B0604020202020204" pitchFamily="34" charset="0"/>
                  <a:cs typeface="Arial" panose="020B0604020202020204" pitchFamily="34" charset="0"/>
                </a:rPr>
                <a:t>Change in MWST score</a:t>
              </a:r>
              <a:endParaRPr kumimoji="1" lang="ja-JP" altLang="en-US" sz="121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0" name="図 29">
            <a:extLst>
              <a:ext uri="{FF2B5EF4-FFF2-40B4-BE49-F238E27FC236}">
                <a16:creationId xmlns:a16="http://schemas.microsoft.com/office/drawing/2014/main" id="{C2281E68-9509-E8CC-3A98-2C41A16971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6449529" y="4309815"/>
            <a:ext cx="90872" cy="90872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9E1CDB13-E694-7E1B-F112-911E3DB350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6534199" y="4309815"/>
            <a:ext cx="90872" cy="90872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80F207E3-E728-8A7F-F659-C081C7DDD2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6618869" y="4309815"/>
            <a:ext cx="90872" cy="90872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2A5D196A-7D88-8937-7D67-60E44ECFFA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881510" y="4313197"/>
            <a:ext cx="90872" cy="90872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338664DD-7508-2703-9B13-A3416333D0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966180" y="4313197"/>
            <a:ext cx="90872" cy="90872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66210069-F589-9CAF-C90D-E05DEEE517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5050850" y="4313197"/>
            <a:ext cx="90872" cy="90872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DEED5947-8D8B-4B7A-8033-A863C878D8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881986" y="4024704"/>
            <a:ext cx="90872" cy="90872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F41BBD45-826C-3BA9-259F-75543F19E5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966656" y="4024704"/>
            <a:ext cx="90872" cy="90872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ACCFE940-EA85-D318-4F1A-493098DE5E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5051326" y="4024704"/>
            <a:ext cx="90872" cy="90872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D35A924C-0CDF-0561-19F1-CF68B1AB13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881986" y="4166894"/>
            <a:ext cx="90872" cy="90872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79CB7443-368F-BB7F-A71F-9A4AE57275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966656" y="4166894"/>
            <a:ext cx="90872" cy="90872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8D30712D-864A-B2C4-12F3-C6C72213A6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5051326" y="4166894"/>
            <a:ext cx="90872" cy="90872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88E82081-2D99-E64A-8AB1-3BB15991BB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8010780" y="4306425"/>
            <a:ext cx="90872" cy="90872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E337B6E9-DE5C-D496-FA38-28B257BC7E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878131" y="4448662"/>
            <a:ext cx="90872" cy="90872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93A0BB1E-D71B-ACC3-AACD-5FA4376551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4881517" y="3744238"/>
            <a:ext cx="90872" cy="90872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E4492833-62AB-79A0-D086-EF1A3DE500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6706918" y="4309817"/>
            <a:ext cx="90872" cy="90872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C5E95AB8-546D-366B-51C2-DEFAE17CF6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8095450" y="4303041"/>
            <a:ext cx="90872" cy="90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3815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76</TotalTime>
  <Words>23</Words>
  <Application>Microsoft Office PowerPoint</Application>
  <PresentationFormat>ワイド画面</PresentationFormat>
  <Paragraphs>7</Paragraphs>
  <Slides>3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ichiro Aoyagi</dc:creator>
  <cp:lastModifiedBy>Yoichiro Aoyagi</cp:lastModifiedBy>
  <cp:revision>2</cp:revision>
  <cp:lastPrinted>2025-04-30T11:46:31Z</cp:lastPrinted>
  <dcterms:created xsi:type="dcterms:W3CDTF">2024-06-09T11:15:05Z</dcterms:created>
  <dcterms:modified xsi:type="dcterms:W3CDTF">2025-08-25T03:04:18Z</dcterms:modified>
</cp:coreProperties>
</file>